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72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l="36696" t="8772" r="32146" b="8373"/>
          <a:stretch>
            <a:fillRect/>
          </a:stretch>
        </p:blipFill>
        <p:spPr bwMode="auto">
          <a:xfrm>
            <a:off x="1556792" y="395536"/>
            <a:ext cx="3168352" cy="5265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260648" y="25152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6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2696" y="5868144"/>
            <a:ext cx="55446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6: Gene ontology enrichment analysis of maize genes induced after infection with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train SG200∆tin3 at 4 dpi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</a:t>
            </a:r>
            <a:r>
              <a:rPr lang="en-US" sz="1200" smtClean="0">
                <a:solidFill>
                  <a:srgbClr val="00B0F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(yellow boxes) that are specifically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tin3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5:22Z</dcterms:modified>
</cp:coreProperties>
</file>